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857D2-B51B-45B0-07B4-D793D5016A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E2FFDD-0B97-5DEA-8E31-969BC9817F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0F4B7-4610-CD45-C8CB-246E7834D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2D8FCA-4F22-E0F1-0079-CC51C2FE3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9C9C5-81DD-2E00-FA42-1E47F4F9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943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6A1BD1-63CC-CE8B-8DCD-57AEDE7F4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671B9A-BE17-48DE-92F4-4D949F8364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3A8814-5A16-F8F4-0377-ACE9E9F6E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E8E89-86E3-A047-B617-F85AA801A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8584A-5E1A-9F47-4B06-7E18E6847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52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77455D-358A-53AF-34E9-321DA9ADE1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30ED78-B16D-32E2-3B8F-87DEC63245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31EE6-64FD-741A-5BF0-937BEE804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B62C6D-9C98-3C0E-124A-82D9425BB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03410-AAAA-CD87-7527-7B8B63F39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406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C2010-AE36-D0B8-0DBB-1A0F53608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C6EB8B-4AAD-E52E-4383-2521F734FB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F22A53-1CA2-E3EB-3DF5-3984EB6E7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BC6AEA-382C-9B6A-9460-2EFCBAD44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A323F-F7D9-C407-CC43-CC2200380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244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4177D-90ED-EDC5-60ED-0528EEE1D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2B65B2-613C-4B39-9FDC-4C0EE4D64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CA1A8-AD57-59EA-0DC3-4E13F7E8C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9B526-B6A3-BDBE-1B4E-27277452D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E672FB-7520-5FFC-582C-91E652BF0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23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01771-5F76-BBC4-EDD7-6970CAD4E4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DD279D-7BE0-87FC-A24C-80965A722C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51FCAD-AB67-CC9D-33C1-A1A1AEFBA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ADE939-BFD7-79B6-11FA-335118652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F49923-ACC9-FD2A-569E-5F9BFC94E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496D1D-E187-F8DB-BC14-F49BA4191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0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A8010-A4BB-D73A-15C2-75331E5655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00D18B-782E-6E21-9D6E-726CA4008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BDD9B7-79C0-DEA3-67D8-0929F62496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CF7036-9C3C-856D-3E94-303F59AAE0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44094D-D55D-CCBE-8068-199157E3AF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25B875-0615-5174-0B72-7F182CDC8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3CEEB5-88AE-D217-947D-E33EEAF79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32CD01-CFA0-2891-BAB9-352A78083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207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897DE-B757-BAAB-F9CF-81FF5AC0C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CE512D-C1A5-047B-BCAD-45F2B058D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325C91-6E12-FB6B-BBD4-4DB406686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D783C9-CBA2-53F1-D1FA-9659A3721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04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D4C82F-5BCB-1A91-281C-327B294FB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856048-BD0C-33F8-7CBE-1B7CC55D1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490C40-3184-34C4-6786-F5F018B1A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079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9B664-4CBA-B21C-94B2-F82562EAA4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F052E-7FE9-6B99-6F6D-E0F7B479DB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44E531-9356-8965-6131-E076A5000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994453-ACA9-B9C9-2B14-3B806C038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0AE799-747B-3B60-5166-8A8FFD5A9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F197F3-C836-E5D3-161D-36D8E49D6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672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5F5F0-4DEA-4676-E468-17C49AD66E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F55E3A-5F30-4313-0566-7A143D042C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F600DF-2BFB-E467-C1D9-5AD2A8D69E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080E8D-E603-23A9-DEAF-91AC924C1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C3F339-E9AA-9F8E-3707-06105926C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6688F7-AD64-49EE-E154-C9BEDE5C0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935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8BEDED-B92B-0CCB-3374-FD2A0C956C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2F8F0C-E733-A406-C588-8CC82FD966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B46B3-A80F-AF62-0AE0-8C00D27C91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B6CE21-346A-3F49-8680-935C68ACDA4D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D182AD-9A2F-756C-0745-4D90A8C043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FB3D13-F044-0BDD-8DE0-52011D3EA3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14A957-0229-7947-B0D7-FF9AFBF423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509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B9637AC-CAFD-4081-0095-BD64359D3E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5240465"/>
              </p:ext>
            </p:extLst>
          </p:nvPr>
        </p:nvGraphicFramePr>
        <p:xfrm>
          <a:off x="2926821" y="2410460"/>
          <a:ext cx="5415837" cy="214503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181098">
                  <a:extLst>
                    <a:ext uri="{9D8B030D-6E8A-4147-A177-3AD203B41FA5}">
                      <a16:colId xmlns:a16="http://schemas.microsoft.com/office/drawing/2014/main" val="858430590"/>
                    </a:ext>
                  </a:extLst>
                </a:gridCol>
                <a:gridCol w="904874">
                  <a:extLst>
                    <a:ext uri="{9D8B030D-6E8A-4147-A177-3AD203B41FA5}">
                      <a16:colId xmlns:a16="http://schemas.microsoft.com/office/drawing/2014/main" val="3368550896"/>
                    </a:ext>
                  </a:extLst>
                </a:gridCol>
                <a:gridCol w="1262942">
                  <a:extLst>
                    <a:ext uri="{9D8B030D-6E8A-4147-A177-3AD203B41FA5}">
                      <a16:colId xmlns:a16="http://schemas.microsoft.com/office/drawing/2014/main" val="297261055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4037853531"/>
                    </a:ext>
                  </a:extLst>
                </a:gridCol>
                <a:gridCol w="1038223">
                  <a:extLst>
                    <a:ext uri="{9D8B030D-6E8A-4147-A177-3AD203B41FA5}">
                      <a16:colId xmlns:a16="http://schemas.microsoft.com/office/drawing/2014/main" val="1869176981"/>
                    </a:ext>
                  </a:extLst>
                </a:gridCol>
              </a:tblGrid>
              <a:tr h="361950">
                <a:tc gridSpan="5">
                  <a:txBody>
                    <a:bodyPr/>
                    <a:lstStyle/>
                    <a:p>
                      <a:pPr lvl="0" algn="l">
                        <a:buNone/>
                      </a:pPr>
                      <a:r>
                        <a:rPr lang="en-US" sz="1100" b="1" i="0" u="none" strike="noStrike" noProof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Calibri"/>
                        </a:rPr>
                        <a:t>Supplemental Table S3:</a:t>
                      </a:r>
                      <a:r>
                        <a:rPr lang="en-US" sz="1100" b="0" i="0" u="none" strike="noStrike" noProof="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Calibri"/>
                        </a:rPr>
                        <a:t>   Sex differences among dermatologic irAE odds ratio (OR, 95% CI)</a:t>
                      </a:r>
                      <a:endParaRPr lang="en-US" sz="1800" dirty="0"/>
                    </a:p>
                  </a:txBody>
                  <a:tcPr marL="76200" marR="76200" marT="38100" marB="38100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6674" marR="66674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6674" marR="66674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6674" marR="66674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740675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endParaRPr lang="en-US" sz="900" b="1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1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Unadjusted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Asymptotic Logistic model adjusted by age, sex, and ICI therapy</a:t>
                      </a:r>
                      <a:r>
                        <a:rPr lang="en-US" sz="900" b="1" baseline="30000" dirty="0">
                          <a:effectLst/>
                          <a:latin typeface="+mn-lt"/>
                        </a:rPr>
                        <a:t>1</a:t>
                      </a:r>
                      <a:r>
                        <a:rPr lang="en-US" sz="900" b="1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76200" marR="76200" marT="38100" marB="38100" anchor="ctr">
                    <a:lnL>
                      <a:noFill/>
                    </a:lnL>
                    <a:lnR>
                      <a:noFill/>
                    </a:lnR>
                    <a:lnT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439893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Risk factor  </a:t>
                      </a:r>
                    </a:p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definition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Outcome: irAE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OR (95% CI)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aOR (95% CI) </a:t>
                      </a:r>
                    </a:p>
                  </a:txBody>
                  <a:tcPr marL="76200" marR="76200" marT="38100" marB="3810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464953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rtl="0" fontAlgn="base"/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DERM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among Men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among Women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381912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NLR&lt;4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1.62 (0.75, 3.52)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90 (0.32, 2.49)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4.41 (1.17, 16.6)</a:t>
                      </a:r>
                      <a:r>
                        <a:rPr lang="en-US" sz="900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8651655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NLR&lt;5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2.06 (0.85, 5.00)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1.04 (0.34, 3.14)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12.2 (1.40, 106)</a:t>
                      </a:r>
                      <a:r>
                        <a:rPr lang="en-US" sz="900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726808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F366B7B-C255-4125-BBEE-43F145202A25}"/>
              </a:ext>
            </a:extLst>
          </p:cNvPr>
          <p:cNvSpPr txBox="1"/>
          <p:nvPr/>
        </p:nvSpPr>
        <p:spPr>
          <a:xfrm>
            <a:off x="2926080" y="4559300"/>
            <a:ext cx="6548120" cy="1538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38100" tIns="19050" rIns="38100" bIns="1905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50" baseline="30000" dirty="0">
                <a:ea typeface="+mn-lt"/>
                <a:cs typeface="+mn-lt"/>
              </a:rPr>
              <a:t>1</a:t>
            </a:r>
            <a:r>
              <a:rPr lang="en-US" sz="750" dirty="0">
                <a:ea typeface="+mn-lt"/>
                <a:cs typeface="+mn-lt"/>
              </a:rPr>
              <a:t>Tested for interactions with age, sex, and ICI therapy (combination or IPI only) and shown as such when p-value for interaction is &lt;0.10.</a:t>
            </a:r>
          </a:p>
        </p:txBody>
      </p:sp>
    </p:spTree>
    <p:extLst>
      <p:ext uri="{BB962C8B-B14F-4D97-AF65-F5344CB8AC3E}">
        <p14:creationId xmlns:p14="http://schemas.microsoft.com/office/powerpoint/2010/main" val="670041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nningham, Michael Montana</dc:creator>
  <cp:lastModifiedBy>MDPI</cp:lastModifiedBy>
  <cp:revision>2</cp:revision>
  <dcterms:created xsi:type="dcterms:W3CDTF">2025-06-16T16:54:35Z</dcterms:created>
  <dcterms:modified xsi:type="dcterms:W3CDTF">2025-06-17T03:52:01Z</dcterms:modified>
</cp:coreProperties>
</file>